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  <p:sldId id="257" r:id="rId3"/>
    <p:sldId id="258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40"/>
    <p:restoredTop sz="94640"/>
  </p:normalViewPr>
  <p:slideViewPr>
    <p:cSldViewPr snapToGrid="0" snapToObjects="1">
      <p:cViewPr varScale="1">
        <p:scale>
          <a:sx n="70" d="100"/>
          <a:sy n="70" d="100"/>
        </p:scale>
        <p:origin x="184" y="8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37CDC8-E9A1-7349-A6B4-9E41C663A9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EA8A3D5-5DC6-8742-A733-59FA0E6E5E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39F85D-84FE-344C-AC33-44CC902531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CB3B6B-2398-3748-9FF3-FCD6868C0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277BE9-F5E4-3A47-997E-FBD8690D1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999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2B21F0-76C5-6847-A694-8ED38BF87C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12E05A-9B5D-8F42-9056-C0598E8B86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9EC66E-906A-D748-83FC-D42A7F2A6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DCA6B9-65CA-504D-88E2-90FAB829CD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2D6B88-7052-2C43-896C-C73215FC5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713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E3E29C-135F-034C-A336-27CC5C164F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8209A6-8099-F645-B67B-E43E17FD16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20F52C-85F1-F749-B898-94641E922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DDA635-6F01-1B46-8433-71CD0BCAA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B90CF5-BB51-644E-A849-3236458FD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390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8FA5F-4D03-EE46-BD29-C39879F16D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F4A490-BCC8-AE4E-8A45-CBB345275D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E1B169-558A-5E4B-BF49-7D7F6F1161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D89B0B-3336-A84E-9F6A-99D93CFC4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E3BBD8-9F07-BE47-B143-D9220EF6C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831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FB128E-44CF-E24B-A148-792361FB9E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FCB527-3644-D54E-A376-FD9B7DB617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B92709-780C-9A4B-840D-617E8D848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1A6FBF-5714-E648-8C42-F7546B5D5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946F2C-5640-B747-AB15-154510AC4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544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EB6926-7E6B-3449-BE07-DA34678D56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AA2883-DF07-5447-8C66-B1BCFE8B25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DB4CD2-77B5-EA48-8432-5C07122C51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50C1C5-8C86-8B49-BE5D-840BB14ED2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3AC727-91BF-CE41-97A5-CF7D50055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3EE69B-9F4E-5C44-8BDE-B8A4C8DDA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962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A71F63-18CD-AC4B-B300-3CF0E10FC6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BBA6AF-51DC-AC4D-89A8-EEC4D8D8F8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B1F145-286E-7140-836B-FD6CA6C946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E7FDE6-60E3-6241-83DE-50D2B0FD2A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08DF869-8397-DD4F-91B5-2ABABA27B8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1C49058-9032-9E4B-9497-BFCCB1EE9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032BBE1-280C-6749-B440-83FCE3F8C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E44130-89DD-194A-954B-F545FB62D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01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58B6ED-9E00-5548-BB49-BA6A5EAA52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C92FEBA-41D5-904F-A3B9-0931B8920A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26107A0-89DD-284B-94C5-E3D84D80D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15B9DBD-03B6-7246-99F5-82112010B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10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7F948B-250B-064E-BE88-DB72CBB1E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0553AAA-8223-FB45-8D62-8810ED7BA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4899AB3-C5E1-7949-B829-8815DC51E3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983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3E1D88-2C0E-C94C-A453-B5754B650C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5A8623-A9A6-F843-BCF2-519FD60285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B0ADEA-0708-3B46-99D1-7AFBC1012D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142AC1-D99E-A04A-A004-7C1D7974D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407764-7B00-444F-899F-0BF2902F4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AD92F7-2EDD-7446-BE81-161CEEF70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08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A742E-8DD6-DA48-8595-0511B28207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F816EE-9F3E-8345-8C42-802DD04740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DC3109-AA34-0944-8687-AC0F9C5A9C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6D7C96-C663-D74E-A3A9-2970268FF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5E9449-ECC7-DB47-B2BB-D0CC60CE6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832BA0-64B9-3F41-AE0D-CBB70B0EA1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849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F5C40E3-291D-264C-BF4F-74BD5A6C04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7A8326-3A50-3D40-9279-8B1921B116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4AFEA4-433E-7F4A-976F-2104F16010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DB3D60-D6CE-3B4D-B89B-9030055347E9}" type="datetimeFigureOut">
              <a:rPr lang="en-US" smtClean="0"/>
              <a:t>6/1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AA08EC-A027-B14D-826B-FAFA6BC639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FCF8BD-75E4-124D-BB12-8C82AA3899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4A0C5D-BAE4-094F-8DAD-9B347361B6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854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6BE6C-2402-8548-9D19-FCD36336E6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1624" y="2486533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Triage Data From Epic Playground</a:t>
            </a:r>
          </a:p>
        </p:txBody>
      </p:sp>
    </p:spTree>
    <p:extLst>
      <p:ext uri="{BB962C8B-B14F-4D97-AF65-F5344CB8AC3E}">
        <p14:creationId xmlns:p14="http://schemas.microsoft.com/office/powerpoint/2010/main" val="6408244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9C0420-4B7F-6449-B631-40DCE28450C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866600-4ACF-7542-8FBB-6984A8A3D95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49C0FDF-817A-6F45-81FF-D0EA1C3925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225" y="641089"/>
            <a:ext cx="9601549" cy="53939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73979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21681D6-FAA9-754E-A7A5-686475ACDD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6464" y="2495854"/>
            <a:ext cx="8844214" cy="436214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3066EA9-4777-D542-BD22-B1289F0592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6464" y="158121"/>
            <a:ext cx="8997696" cy="23377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32752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30AFA8-6046-D04C-83DC-97C152567F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29640" y="2614549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Alternative presentation of triage data</a:t>
            </a:r>
          </a:p>
        </p:txBody>
      </p:sp>
    </p:spTree>
    <p:extLst>
      <p:ext uri="{BB962C8B-B14F-4D97-AF65-F5344CB8AC3E}">
        <p14:creationId xmlns:p14="http://schemas.microsoft.com/office/powerpoint/2010/main" val="4313843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25B8F71-6D37-0E44-8578-5630625076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620175"/>
            <a:ext cx="10401674" cy="5556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1939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10</Words>
  <Application>Microsoft Macintosh PowerPoint</Application>
  <PresentationFormat>Widescreen</PresentationFormat>
  <Paragraphs>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Triage Data From Epic Playground</vt:lpstr>
      <vt:lpstr>PowerPoint Presentation</vt:lpstr>
      <vt:lpstr>PowerPoint Presentation</vt:lpstr>
      <vt:lpstr>Alternative presentation of triage data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ley Christine Rider</dc:creator>
  <cp:lastModifiedBy>Ashley Christine Rider</cp:lastModifiedBy>
  <cp:revision>4</cp:revision>
  <dcterms:created xsi:type="dcterms:W3CDTF">2020-06-13T01:50:56Z</dcterms:created>
  <dcterms:modified xsi:type="dcterms:W3CDTF">2020-06-13T03:11:28Z</dcterms:modified>
</cp:coreProperties>
</file>